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1" r:id="rId3"/>
    <p:sldId id="263" r:id="rId4"/>
    <p:sldId id="264" r:id="rId5"/>
    <p:sldId id="268" r:id="rId6"/>
    <p:sldId id="265" r:id="rId7"/>
    <p:sldId id="266" r:id="rId8"/>
    <p:sldId id="267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138E43F-7444-44C5-B240-8371BD31A2AC}" v="2" dt="2021-02-26T17:18:47.93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0" autoAdjust="0"/>
    <p:restoredTop sz="94660"/>
  </p:normalViewPr>
  <p:slideViewPr>
    <p:cSldViewPr snapToGrid="0">
      <p:cViewPr varScale="1">
        <p:scale>
          <a:sx n="54" d="100"/>
          <a:sy n="54" d="100"/>
        </p:scale>
        <p:origin x="111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microsoft.com/office/2015/10/relationships/revisionInfo" Target="revisionInfo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36906A-A983-4120-9285-6E575E6606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F80C24F-DBB8-4104-8CBA-F95FBF67219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A1A947-59D7-4019-B43A-8FD04AF8F3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276A-9493-4387-973E-07520441AB37}" type="datetimeFigureOut">
              <a:rPr lang="en-GB" smtClean="0"/>
              <a:t>28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1BE370-65C9-45E5-83AC-10F7187F52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C7F3FB-AF28-49B9-837E-56E9157B6D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644CB-0AE1-470C-AED2-94D3C86EB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0013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D066D5-D7A8-4F65-B539-5EBC642F2D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A592C0-A4DB-41A8-AD82-1B7EBD1DA6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4BE456-DB4E-46C0-A424-E8015BBC69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276A-9493-4387-973E-07520441AB37}" type="datetimeFigureOut">
              <a:rPr lang="en-GB" smtClean="0"/>
              <a:t>28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9A3468-7A88-4A41-B6FE-4B438FA705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732ED2-3B63-496F-B2CF-C06CE6CAC4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644CB-0AE1-470C-AED2-94D3C86EB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22087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7A6D8A1-F281-442A-840F-3FA6476B3B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82F25F-7435-4001-A4AF-F1335B8399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AAC425-6C63-437E-A120-349F6FD21F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276A-9493-4387-973E-07520441AB37}" type="datetimeFigureOut">
              <a:rPr lang="en-GB" smtClean="0"/>
              <a:t>28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92A9CA-B547-46C6-9C32-3626527E56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8CD8FA-DBBE-48BA-BA83-E077A3728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644CB-0AE1-470C-AED2-94D3C86EB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3245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95BE07-C1BE-45C8-BC15-39C73E7FBF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832D6D-20BC-4ABD-A07B-A98B85AC5A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23DCC0-378B-4667-A318-43D6EE7CC6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276A-9493-4387-973E-07520441AB37}" type="datetimeFigureOut">
              <a:rPr lang="en-GB" smtClean="0"/>
              <a:t>28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DE8DF6-5E4B-4709-A03A-187ED8FF01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79B12D-8A30-4B6C-96A4-FB8E7F2684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644CB-0AE1-470C-AED2-94D3C86EB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9871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15B13A-6392-4E15-A4E5-2C529D198D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E9CE3D-B5CD-45E1-AD40-598EEEA44C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3C8958-70E9-4A19-BAC3-39DC76591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276A-9493-4387-973E-07520441AB37}" type="datetimeFigureOut">
              <a:rPr lang="en-GB" smtClean="0"/>
              <a:t>28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60838A-5A75-4ABC-86A3-95152E8BE7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210223-FF8F-4AC2-A3E7-65A788F18C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644CB-0AE1-470C-AED2-94D3C86EB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2068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A5FF1A-2D31-4CD3-9BEB-D76AEAF8CF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81E48E-F815-486D-B9E4-F05EB4CBE9B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BC18D3-4351-4EF1-A39C-4D340370B9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8B5949-C0E2-4749-9D6F-3B9538B752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276A-9493-4387-973E-07520441AB37}" type="datetimeFigureOut">
              <a:rPr lang="en-GB" smtClean="0"/>
              <a:t>28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9CE17D-7357-4FC7-94BC-EE72482B4B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C41BE9-7FBF-49C1-AF03-8701528DD6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644CB-0AE1-470C-AED2-94D3C86EB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5271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8B8BB6-5F48-465F-BB18-8C576905E2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901976-C293-4A29-B5F8-AB75C3F9F9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94F3C21-8BBF-4E12-B45D-4E1CF6C1A2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8E56EFA-27EC-4551-BBA8-4C7028FB77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4E80111-858E-48B9-BD38-A87248B3A2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8D59F5A-AEC6-4F4C-B30E-87A605D6AD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276A-9493-4387-973E-07520441AB37}" type="datetimeFigureOut">
              <a:rPr lang="en-GB" smtClean="0"/>
              <a:t>28/04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DC14F2E-91D9-49CB-8838-2158102CB1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A1D9744-088F-44C8-A308-A6A97F0F00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644CB-0AE1-470C-AED2-94D3C86EB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77494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FFADE0-ACBD-4F5D-A870-4BD83E64E6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AD6D4A2-EE7A-40FE-9048-28CEF28BF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276A-9493-4387-973E-07520441AB37}" type="datetimeFigureOut">
              <a:rPr lang="en-GB" smtClean="0"/>
              <a:t>28/04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0E1F18-83D9-4AB1-A05C-16F68E1684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FC567FB-7279-4221-AF27-F0AB150EE0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644CB-0AE1-470C-AED2-94D3C86EB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49643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F12E59C-90AE-4238-BAA1-B7B472C3FB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276A-9493-4387-973E-07520441AB37}" type="datetimeFigureOut">
              <a:rPr lang="en-GB" smtClean="0"/>
              <a:t>28/04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62DAD59-34A8-4066-8359-BB3FD8068B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FE50F16-8D5F-4998-B98E-5B55F11A95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644CB-0AE1-470C-AED2-94D3C86EB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9625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56194E-D190-4473-98AD-CED2E5173D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80FA4D-2E25-4EE9-A956-6CB9A89226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21A051-D761-45D7-8F2E-7D8A24294E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0C8E47-892D-4ED3-A47D-C24D8D62E1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276A-9493-4387-973E-07520441AB37}" type="datetimeFigureOut">
              <a:rPr lang="en-GB" smtClean="0"/>
              <a:t>28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AE0040-11F6-48D3-A26A-9DBE79DA0E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65C441-88CA-4517-89E7-11889CC79F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644CB-0AE1-470C-AED2-94D3C86EB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82892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7BC4D0-9287-4E09-B188-7BD209CD90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C1A212A-4467-4C68-87FE-86FBB30B6CD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E8719B-47D0-491A-A5AE-BA9A1B8727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246DCA-3897-46AC-A091-BA4ECD8796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276A-9493-4387-973E-07520441AB37}" type="datetimeFigureOut">
              <a:rPr lang="en-GB" smtClean="0"/>
              <a:t>28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D3203B-9A09-469F-A023-256436755F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3034EF-6A02-48A7-BBFC-A215D9798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644CB-0AE1-470C-AED2-94D3C86EB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70343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51DAE2D-E3EC-4266-BFB2-514B4D754C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570943-7A54-468D-8C82-4E112399BC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6F28EF-5A9F-4B15-B5B7-9F58091FB1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36276A-9493-4387-973E-07520441AB37}" type="datetimeFigureOut">
              <a:rPr lang="en-GB" smtClean="0"/>
              <a:t>28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96E4A7-C53F-4150-93BD-CAC30A015B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C37F54-48BB-4C33-A921-27D7076DD1A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4644CB-0AE1-470C-AED2-94D3C86EB6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4934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sv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2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64" descr="A close up of a device&#10;&#10;Description automatically generated">
            <a:extLst>
              <a:ext uri="{FF2B5EF4-FFF2-40B4-BE49-F238E27FC236}">
                <a16:creationId xmlns:a16="http://schemas.microsoft.com/office/drawing/2014/main" id="{B35F88C9-C946-47AB-8DD6-0236DC3C04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9366" y="4350496"/>
            <a:ext cx="2209903" cy="2209903"/>
          </a:xfrm>
          <a:prstGeom prst="rect">
            <a:avLst/>
          </a:prstGeom>
        </p:spPr>
      </p:pic>
      <p:pic>
        <p:nvPicPr>
          <p:cNvPr id="63" name="Picture 62" descr="A screenshot of a cell phone&#10;&#10;Description automatically generated">
            <a:extLst>
              <a:ext uri="{FF2B5EF4-FFF2-40B4-BE49-F238E27FC236}">
                <a16:creationId xmlns:a16="http://schemas.microsoft.com/office/drawing/2014/main" id="{717A4E0B-1ED6-42DC-BAFE-56054D6CF0D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9154" y="4350497"/>
            <a:ext cx="2209902" cy="2209902"/>
          </a:xfrm>
          <a:prstGeom prst="rect">
            <a:avLst/>
          </a:prstGeom>
        </p:spPr>
      </p:pic>
      <p:pic>
        <p:nvPicPr>
          <p:cNvPr id="61" name="Picture 60" descr="A screenshot of a cell phone&#10;&#10;Description automatically generated">
            <a:extLst>
              <a:ext uri="{FF2B5EF4-FFF2-40B4-BE49-F238E27FC236}">
                <a16:creationId xmlns:a16="http://schemas.microsoft.com/office/drawing/2014/main" id="{40F1A071-1385-4914-9A99-60006153FBF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416" y="4350497"/>
            <a:ext cx="2209902" cy="2209902"/>
          </a:xfrm>
          <a:prstGeom prst="rect">
            <a:avLst/>
          </a:prstGeom>
        </p:spPr>
      </p:pic>
      <p:pic>
        <p:nvPicPr>
          <p:cNvPr id="59" name="Picture 58" descr="A close up of a device&#10;&#10;Description automatically generated">
            <a:extLst>
              <a:ext uri="{FF2B5EF4-FFF2-40B4-BE49-F238E27FC236}">
                <a16:creationId xmlns:a16="http://schemas.microsoft.com/office/drawing/2014/main" id="{2ACBCE2F-99F3-4192-9CF1-47D0BF5D35A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9873" y="2140595"/>
            <a:ext cx="2209903" cy="2209903"/>
          </a:xfrm>
          <a:prstGeom prst="rect">
            <a:avLst/>
          </a:prstGeom>
        </p:spPr>
      </p:pic>
      <p:pic>
        <p:nvPicPr>
          <p:cNvPr id="57" name="Picture 56" descr="A screenshot of a cell phone&#10;&#10;Description automatically generated">
            <a:extLst>
              <a:ext uri="{FF2B5EF4-FFF2-40B4-BE49-F238E27FC236}">
                <a16:creationId xmlns:a16="http://schemas.microsoft.com/office/drawing/2014/main" id="{B7C890DE-4249-4F9B-87EE-02225222639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7684" y="2140595"/>
            <a:ext cx="2209902" cy="2209902"/>
          </a:xfrm>
          <a:prstGeom prst="rect">
            <a:avLst/>
          </a:prstGeom>
        </p:spPr>
      </p:pic>
      <p:pic>
        <p:nvPicPr>
          <p:cNvPr id="55" name="Picture 54" descr="A screenshot of a cell phone&#10;&#10;Description automatically generated">
            <a:extLst>
              <a:ext uri="{FF2B5EF4-FFF2-40B4-BE49-F238E27FC236}">
                <a16:creationId xmlns:a16="http://schemas.microsoft.com/office/drawing/2014/main" id="{C0D69B10-536A-4741-9A2B-B1179F184EB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455" y="2140595"/>
            <a:ext cx="2209902" cy="2209902"/>
          </a:xfrm>
          <a:prstGeom prst="rect">
            <a:avLst/>
          </a:prstGeom>
        </p:spPr>
      </p:pic>
      <p:pic>
        <p:nvPicPr>
          <p:cNvPr id="26" name="Picture 25" descr="A screenshot of a cell phone&#10;&#10;Description automatically generated">
            <a:extLst>
              <a:ext uri="{FF2B5EF4-FFF2-40B4-BE49-F238E27FC236}">
                <a16:creationId xmlns:a16="http://schemas.microsoft.com/office/drawing/2014/main" id="{410B9FF9-24C8-4E02-997C-4E36A87668B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8912" y="56678"/>
            <a:ext cx="2209902" cy="2209902"/>
          </a:xfrm>
          <a:prstGeom prst="rect">
            <a:avLst/>
          </a:prstGeom>
        </p:spPr>
      </p:pic>
      <p:pic>
        <p:nvPicPr>
          <p:cNvPr id="17" name="Picture 16" descr="A close up of a device&#10;&#10;Description automatically generated">
            <a:extLst>
              <a:ext uri="{FF2B5EF4-FFF2-40B4-BE49-F238E27FC236}">
                <a16:creationId xmlns:a16="http://schemas.microsoft.com/office/drawing/2014/main" id="{7A1BC6F5-C1A3-4A8C-9526-38ABDCD0FD4D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7683" y="56678"/>
            <a:ext cx="2209903" cy="2209903"/>
          </a:xfrm>
          <a:prstGeom prst="rect">
            <a:avLst/>
          </a:prstGeom>
        </p:spPr>
      </p:pic>
      <p:pic>
        <p:nvPicPr>
          <p:cNvPr id="12" name="Picture 11" descr="A close up of a device&#10;&#10;Description automatically generated">
            <a:extLst>
              <a:ext uri="{FF2B5EF4-FFF2-40B4-BE49-F238E27FC236}">
                <a16:creationId xmlns:a16="http://schemas.microsoft.com/office/drawing/2014/main" id="{A2BC397A-B6ED-41E3-8612-D51420CC089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455" y="56680"/>
            <a:ext cx="2209902" cy="220990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BB512CD-AD68-4D32-A853-28FBBEC6513B}"/>
              </a:ext>
            </a:extLst>
          </p:cNvPr>
          <p:cNvSpPr txBox="1"/>
          <p:nvPr/>
        </p:nvSpPr>
        <p:spPr>
          <a:xfrm>
            <a:off x="687295" y="510079"/>
            <a:ext cx="816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λ</a:t>
            </a:r>
            <a:r>
              <a:rPr lang="en-GB" dirty="0"/>
              <a:t>=1.19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9E62AD8-A764-40C3-BF9D-982D53B4D923}"/>
              </a:ext>
            </a:extLst>
          </p:cNvPr>
          <p:cNvSpPr txBox="1"/>
          <p:nvPr/>
        </p:nvSpPr>
        <p:spPr>
          <a:xfrm>
            <a:off x="684051" y="2661345"/>
            <a:ext cx="816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λ</a:t>
            </a:r>
            <a:r>
              <a:rPr lang="en-GB" dirty="0"/>
              <a:t>=0.74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91BCBE3-87A2-435E-93D0-76BAC858B64C}"/>
              </a:ext>
            </a:extLst>
          </p:cNvPr>
          <p:cNvSpPr txBox="1"/>
          <p:nvPr/>
        </p:nvSpPr>
        <p:spPr>
          <a:xfrm>
            <a:off x="105129" y="15973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8679B38-FBC1-461C-B996-D881BB99FA82}"/>
              </a:ext>
            </a:extLst>
          </p:cNvPr>
          <p:cNvSpPr txBox="1"/>
          <p:nvPr/>
        </p:nvSpPr>
        <p:spPr>
          <a:xfrm>
            <a:off x="2542922" y="16200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3B64EEC-7FCA-4A28-BD14-884637586081}"/>
              </a:ext>
            </a:extLst>
          </p:cNvPr>
          <p:cNvSpPr txBox="1"/>
          <p:nvPr/>
        </p:nvSpPr>
        <p:spPr>
          <a:xfrm>
            <a:off x="5038223" y="179393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C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A2AADE4-642C-4A58-A9CA-F50F9E172B37}"/>
              </a:ext>
            </a:extLst>
          </p:cNvPr>
          <p:cNvSpPr txBox="1"/>
          <p:nvPr/>
        </p:nvSpPr>
        <p:spPr>
          <a:xfrm>
            <a:off x="105129" y="2266581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D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A7A9345-CE90-4966-8727-BFF30507F0BC}"/>
              </a:ext>
            </a:extLst>
          </p:cNvPr>
          <p:cNvSpPr txBox="1"/>
          <p:nvPr/>
        </p:nvSpPr>
        <p:spPr>
          <a:xfrm>
            <a:off x="2571112" y="2266581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83374D2-3B15-4DAF-941B-2D2535524F7A}"/>
              </a:ext>
            </a:extLst>
          </p:cNvPr>
          <p:cNvSpPr txBox="1"/>
          <p:nvPr/>
        </p:nvSpPr>
        <p:spPr>
          <a:xfrm>
            <a:off x="5085186" y="2325906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81273ED-7F0A-4889-8C02-F6EE697579EC}"/>
              </a:ext>
            </a:extLst>
          </p:cNvPr>
          <p:cNvSpPr txBox="1"/>
          <p:nvPr/>
        </p:nvSpPr>
        <p:spPr>
          <a:xfrm>
            <a:off x="3007694" y="548725"/>
            <a:ext cx="816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λ</a:t>
            </a:r>
            <a:r>
              <a:rPr lang="en-GB" dirty="0"/>
              <a:t>=0.94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E93FE03-2AB6-46F3-ABEA-EB0E7B7DF494}"/>
              </a:ext>
            </a:extLst>
          </p:cNvPr>
          <p:cNvSpPr txBox="1"/>
          <p:nvPr/>
        </p:nvSpPr>
        <p:spPr>
          <a:xfrm>
            <a:off x="3007693" y="2635913"/>
            <a:ext cx="816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λ</a:t>
            </a:r>
            <a:r>
              <a:rPr lang="en-GB" dirty="0"/>
              <a:t>=0.74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338241F-BB65-47D9-A89B-CAE23A09E1E1}"/>
              </a:ext>
            </a:extLst>
          </p:cNvPr>
          <p:cNvSpPr txBox="1"/>
          <p:nvPr/>
        </p:nvSpPr>
        <p:spPr>
          <a:xfrm>
            <a:off x="5327522" y="526289"/>
            <a:ext cx="816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λ</a:t>
            </a:r>
            <a:r>
              <a:rPr lang="en-GB" dirty="0"/>
              <a:t>=1.1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E5774EB-B777-433F-BC86-BA5FCB05C3C8}"/>
              </a:ext>
            </a:extLst>
          </p:cNvPr>
          <p:cNvSpPr txBox="1"/>
          <p:nvPr/>
        </p:nvSpPr>
        <p:spPr>
          <a:xfrm>
            <a:off x="5344717" y="2619400"/>
            <a:ext cx="816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λ</a:t>
            </a:r>
            <a:r>
              <a:rPr lang="en-GB" dirty="0"/>
              <a:t>=0.89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12DC767-7F05-4377-AA78-0D9AE1F59994}"/>
              </a:ext>
            </a:extLst>
          </p:cNvPr>
          <p:cNvSpPr txBox="1"/>
          <p:nvPr/>
        </p:nvSpPr>
        <p:spPr>
          <a:xfrm>
            <a:off x="684051" y="4805786"/>
            <a:ext cx="816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λ</a:t>
            </a:r>
            <a:r>
              <a:rPr lang="en-GB" dirty="0"/>
              <a:t>=1.01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4A7496B-C32A-43E5-82E1-1B27716AB433}"/>
              </a:ext>
            </a:extLst>
          </p:cNvPr>
          <p:cNvSpPr txBox="1"/>
          <p:nvPr/>
        </p:nvSpPr>
        <p:spPr>
          <a:xfrm>
            <a:off x="101885" y="4413094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G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90710C3-7F7C-4533-9A21-DCA1A8DD3832}"/>
              </a:ext>
            </a:extLst>
          </p:cNvPr>
          <p:cNvSpPr txBox="1"/>
          <p:nvPr/>
        </p:nvSpPr>
        <p:spPr>
          <a:xfrm>
            <a:off x="2567868" y="4413094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H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130E6100-A99F-4BF1-8423-7754215428D3}"/>
              </a:ext>
            </a:extLst>
          </p:cNvPr>
          <p:cNvSpPr txBox="1"/>
          <p:nvPr/>
        </p:nvSpPr>
        <p:spPr>
          <a:xfrm>
            <a:off x="5081942" y="4472419"/>
            <a:ext cx="2455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I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9C9F8EE-FA27-4B0F-9333-52B5ED15EBF3}"/>
              </a:ext>
            </a:extLst>
          </p:cNvPr>
          <p:cNvSpPr txBox="1"/>
          <p:nvPr/>
        </p:nvSpPr>
        <p:spPr>
          <a:xfrm>
            <a:off x="3007693" y="4803934"/>
            <a:ext cx="816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λ</a:t>
            </a:r>
            <a:r>
              <a:rPr lang="en-GB" dirty="0"/>
              <a:t>=0.94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F3C63014-29E7-40DA-81C1-CCDAB493D4A3}"/>
              </a:ext>
            </a:extLst>
          </p:cNvPr>
          <p:cNvSpPr txBox="1"/>
          <p:nvPr/>
        </p:nvSpPr>
        <p:spPr>
          <a:xfrm>
            <a:off x="5375650" y="4779154"/>
            <a:ext cx="816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λ</a:t>
            </a:r>
            <a:r>
              <a:rPr lang="en-GB" dirty="0"/>
              <a:t>=1.05</a:t>
            </a:r>
          </a:p>
        </p:txBody>
      </p:sp>
    </p:spTree>
    <p:extLst>
      <p:ext uri="{BB962C8B-B14F-4D97-AF65-F5344CB8AC3E}">
        <p14:creationId xmlns:p14="http://schemas.microsoft.com/office/powerpoint/2010/main" val="23776297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D394D2D-4B35-4FB8-9513-CDF88799B90F}"/>
              </a:ext>
            </a:extLst>
          </p:cNvPr>
          <p:cNvSpPr txBox="1"/>
          <p:nvPr/>
        </p:nvSpPr>
        <p:spPr>
          <a:xfrm>
            <a:off x="206170" y="443066"/>
            <a:ext cx="1164170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SF1</a:t>
            </a:r>
            <a:r>
              <a:rPr lang="en-GB" dirty="0"/>
              <a:t>. Sensitivity analyses: QQ plots showing the observed vs expected probabilities per CpG site from the meta-analysis of epigenome-wide association studies of cognitive skills in childhood and DNA methylation in cord blood. Each panel includes a </a:t>
            </a:r>
            <a:r>
              <a:rPr lang="el-GR" dirty="0"/>
              <a:t>λ</a:t>
            </a:r>
            <a:r>
              <a:rPr lang="en-GB" dirty="0"/>
              <a:t> index of genomic inflation. A-C) overall, verbal and non-verbal, in order, analysed as in main models and further adjustment for paternal education; D-F) overall, verbal and non-verbal, in order, adjusted as in main models and with maternal IQ instead of maternal education; G-I) overall, verbal and non-verbal, in order, as in main models with further adjustment for principal components from child’s genetic data.</a:t>
            </a:r>
          </a:p>
        </p:txBody>
      </p:sp>
    </p:spTree>
    <p:extLst>
      <p:ext uri="{BB962C8B-B14F-4D97-AF65-F5344CB8AC3E}">
        <p14:creationId xmlns:p14="http://schemas.microsoft.com/office/powerpoint/2010/main" val="16181023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49" descr="A close up of a logo&#10;&#10;Description automatically generated">
            <a:extLst>
              <a:ext uri="{FF2B5EF4-FFF2-40B4-BE49-F238E27FC236}">
                <a16:creationId xmlns:a16="http://schemas.microsoft.com/office/drawing/2014/main" id="{6AD2C3EA-44AA-4F26-BC76-08416F1A0F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8514" y="4135336"/>
            <a:ext cx="2542922" cy="2542922"/>
          </a:xfrm>
          <a:prstGeom prst="rect">
            <a:avLst/>
          </a:prstGeom>
        </p:spPr>
      </p:pic>
      <p:pic>
        <p:nvPicPr>
          <p:cNvPr id="48" name="Picture 47" descr="A close up of a device&#10;&#10;Description automatically generated">
            <a:extLst>
              <a:ext uri="{FF2B5EF4-FFF2-40B4-BE49-F238E27FC236}">
                <a16:creationId xmlns:a16="http://schemas.microsoft.com/office/drawing/2014/main" id="{96D38337-9D40-4285-A032-A79638F046A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8547" y="4135335"/>
            <a:ext cx="2542923" cy="2542923"/>
          </a:xfrm>
          <a:prstGeom prst="rect">
            <a:avLst/>
          </a:prstGeom>
        </p:spPr>
      </p:pic>
      <p:pic>
        <p:nvPicPr>
          <p:cNvPr id="34" name="Picture 33" descr="A close up of a logo&#10;&#10;Description automatically generated">
            <a:extLst>
              <a:ext uri="{FF2B5EF4-FFF2-40B4-BE49-F238E27FC236}">
                <a16:creationId xmlns:a16="http://schemas.microsoft.com/office/drawing/2014/main" id="{1ABE59C4-5B9A-41DC-9662-65F8990E8B7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536" y="4153076"/>
            <a:ext cx="2542922" cy="2542922"/>
          </a:xfrm>
          <a:prstGeom prst="rect">
            <a:avLst/>
          </a:prstGeom>
        </p:spPr>
      </p:pic>
      <p:pic>
        <p:nvPicPr>
          <p:cNvPr id="14" name="Picture 13" descr="A close up of a logo&#10;&#10;Description automatically generated">
            <a:extLst>
              <a:ext uri="{FF2B5EF4-FFF2-40B4-BE49-F238E27FC236}">
                <a16:creationId xmlns:a16="http://schemas.microsoft.com/office/drawing/2014/main" id="{5D28207A-3BF3-441D-8DD1-3B5A4D32873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7105" y="2114163"/>
            <a:ext cx="2542922" cy="2542922"/>
          </a:xfrm>
          <a:prstGeom prst="rect">
            <a:avLst/>
          </a:prstGeom>
        </p:spPr>
      </p:pic>
      <p:pic>
        <p:nvPicPr>
          <p:cNvPr id="12" name="Picture 11" descr="A close up of a logo&#10;&#10;Description automatically generated">
            <a:extLst>
              <a:ext uri="{FF2B5EF4-FFF2-40B4-BE49-F238E27FC236}">
                <a16:creationId xmlns:a16="http://schemas.microsoft.com/office/drawing/2014/main" id="{03FD7E2D-AB3B-47A1-91B6-6D0FE92F547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8525" y="2114163"/>
            <a:ext cx="2542922" cy="2542922"/>
          </a:xfrm>
          <a:prstGeom prst="rect">
            <a:avLst/>
          </a:prstGeom>
        </p:spPr>
      </p:pic>
      <p:pic>
        <p:nvPicPr>
          <p:cNvPr id="10" name="Picture 9" descr="A close up of a logo&#10;&#10;Description automatically generated">
            <a:extLst>
              <a:ext uri="{FF2B5EF4-FFF2-40B4-BE49-F238E27FC236}">
                <a16:creationId xmlns:a16="http://schemas.microsoft.com/office/drawing/2014/main" id="{9C53E5BA-0D41-4AFF-8BCF-0FDF31ADE8B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603" y="2114163"/>
            <a:ext cx="2542922" cy="2542922"/>
          </a:xfrm>
          <a:prstGeom prst="rect">
            <a:avLst/>
          </a:prstGeom>
        </p:spPr>
      </p:pic>
      <p:pic>
        <p:nvPicPr>
          <p:cNvPr id="8" name="Picture 7" descr="A close up of a device&#10;&#10;Description automatically generated">
            <a:extLst>
              <a:ext uri="{FF2B5EF4-FFF2-40B4-BE49-F238E27FC236}">
                <a16:creationId xmlns:a16="http://schemas.microsoft.com/office/drawing/2014/main" id="{4A7C41EE-D9D9-4780-951A-D9978F3519C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6346" y="92989"/>
            <a:ext cx="2542922" cy="2542922"/>
          </a:xfrm>
          <a:prstGeom prst="rect">
            <a:avLst/>
          </a:prstGeom>
        </p:spPr>
      </p:pic>
      <p:pic>
        <p:nvPicPr>
          <p:cNvPr id="6" name="Picture 5" descr="A close up of a logo&#10;&#10;Description automatically generated">
            <a:extLst>
              <a:ext uri="{FF2B5EF4-FFF2-40B4-BE49-F238E27FC236}">
                <a16:creationId xmlns:a16="http://schemas.microsoft.com/office/drawing/2014/main" id="{32BE6B05-3B27-422E-86EA-85BB5728C77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2867" y="92990"/>
            <a:ext cx="2542923" cy="2542923"/>
          </a:xfrm>
          <a:prstGeom prst="rect">
            <a:avLst/>
          </a:prstGeom>
        </p:spPr>
      </p:pic>
      <p:pic>
        <p:nvPicPr>
          <p:cNvPr id="3" name="Picture 2" descr="A close up of a logo&#10;&#10;Description automatically generated">
            <a:extLst>
              <a:ext uri="{FF2B5EF4-FFF2-40B4-BE49-F238E27FC236}">
                <a16:creationId xmlns:a16="http://schemas.microsoft.com/office/drawing/2014/main" id="{6EF719EB-5C8F-4E97-8A8E-A3C0BECA4300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945" y="92991"/>
            <a:ext cx="2542922" cy="2542922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D495BEE9-A436-4439-BC81-501ED81F6C64}"/>
              </a:ext>
            </a:extLst>
          </p:cNvPr>
          <p:cNvSpPr txBox="1"/>
          <p:nvPr/>
        </p:nvSpPr>
        <p:spPr>
          <a:xfrm>
            <a:off x="105129" y="15973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620EA69-B91A-43B1-AD75-3233519779D0}"/>
              </a:ext>
            </a:extLst>
          </p:cNvPr>
          <p:cNvSpPr txBox="1"/>
          <p:nvPr/>
        </p:nvSpPr>
        <p:spPr>
          <a:xfrm>
            <a:off x="2542922" y="16200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FEF65B2-BE45-4F20-B182-BF3A3DD3D303}"/>
              </a:ext>
            </a:extLst>
          </p:cNvPr>
          <p:cNvSpPr txBox="1"/>
          <p:nvPr/>
        </p:nvSpPr>
        <p:spPr>
          <a:xfrm>
            <a:off x="5038223" y="179393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62C6557-85F4-4BD5-9EA0-664A5D9C1E9F}"/>
              </a:ext>
            </a:extLst>
          </p:cNvPr>
          <p:cNvSpPr txBox="1"/>
          <p:nvPr/>
        </p:nvSpPr>
        <p:spPr>
          <a:xfrm>
            <a:off x="105129" y="2266581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DC38EFA-B93F-4FAE-B364-11DA4FAEF604}"/>
              </a:ext>
            </a:extLst>
          </p:cNvPr>
          <p:cNvSpPr txBox="1"/>
          <p:nvPr/>
        </p:nvSpPr>
        <p:spPr>
          <a:xfrm>
            <a:off x="2571112" y="2266581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F2F4D60-063B-44C2-923B-229C5129156D}"/>
              </a:ext>
            </a:extLst>
          </p:cNvPr>
          <p:cNvSpPr txBox="1"/>
          <p:nvPr/>
        </p:nvSpPr>
        <p:spPr>
          <a:xfrm>
            <a:off x="5085186" y="2325906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B2B7AAA-BBEF-4DE3-96C8-F5223C4DDA44}"/>
              </a:ext>
            </a:extLst>
          </p:cNvPr>
          <p:cNvSpPr txBox="1"/>
          <p:nvPr/>
        </p:nvSpPr>
        <p:spPr>
          <a:xfrm>
            <a:off x="101885" y="4413094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G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07234B7-0DCA-46F6-8693-E32A317C30AD}"/>
              </a:ext>
            </a:extLst>
          </p:cNvPr>
          <p:cNvSpPr txBox="1"/>
          <p:nvPr/>
        </p:nvSpPr>
        <p:spPr>
          <a:xfrm>
            <a:off x="2567868" y="4413094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H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A769248-8845-412B-B271-9E4D11E0F6C3}"/>
              </a:ext>
            </a:extLst>
          </p:cNvPr>
          <p:cNvSpPr txBox="1"/>
          <p:nvPr/>
        </p:nvSpPr>
        <p:spPr>
          <a:xfrm>
            <a:off x="5081942" y="4472419"/>
            <a:ext cx="2455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I</a:t>
            </a:r>
          </a:p>
        </p:txBody>
      </p:sp>
    </p:spTree>
    <p:extLst>
      <p:ext uri="{BB962C8B-B14F-4D97-AF65-F5344CB8AC3E}">
        <p14:creationId xmlns:p14="http://schemas.microsoft.com/office/powerpoint/2010/main" val="25997894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499DC99-D137-460A-9E65-B8D7ABE0C8C5}"/>
              </a:ext>
            </a:extLst>
          </p:cNvPr>
          <p:cNvSpPr txBox="1"/>
          <p:nvPr/>
        </p:nvSpPr>
        <p:spPr>
          <a:xfrm>
            <a:off x="206170" y="443066"/>
            <a:ext cx="1164170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SF2</a:t>
            </a:r>
            <a:r>
              <a:rPr lang="en-GB" dirty="0"/>
              <a:t>. Sensitivity analyses: Volcano plots showing the effect sizes and probability values per CpG site from the meta-analysis of epigenome-wide association studies of cognitive skills in childhood and DNA methylation in cord blood. A-C) overall, verbal and non-verbal, in order, analysed as in main models and further adjustment for paternal education; D-F) overall, verbal and non-verbal, in order, adjusted as in main models and with maternal IQ instead of maternal education; G-I) overall, verbal and non-verbal, in order, as in main models with further adjustment for principal components from child’s genetic data.</a:t>
            </a:r>
          </a:p>
        </p:txBody>
      </p:sp>
    </p:spTree>
    <p:extLst>
      <p:ext uri="{BB962C8B-B14F-4D97-AF65-F5344CB8AC3E}">
        <p14:creationId xmlns:p14="http://schemas.microsoft.com/office/powerpoint/2010/main" val="9510383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box and whisker chart&#10;&#10;Description automatically generated">
            <a:extLst>
              <a:ext uri="{FF2B5EF4-FFF2-40B4-BE49-F238E27FC236}">
                <a16:creationId xmlns:a16="http://schemas.microsoft.com/office/drawing/2014/main" id="{FEE2AB52-660A-46C8-84CC-C39D641281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00" y="434340"/>
            <a:ext cx="4572000" cy="4572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5A9EAC9-0741-494C-A8D1-0D423296C691}"/>
              </a:ext>
            </a:extLst>
          </p:cNvPr>
          <p:cNvSpPr txBox="1"/>
          <p:nvPr/>
        </p:nvSpPr>
        <p:spPr>
          <a:xfrm>
            <a:off x="945832" y="5094655"/>
            <a:ext cx="10747057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/>
              <a:t>Figure SF3</a:t>
            </a:r>
            <a:r>
              <a:rPr lang="en-GB" dirty="0"/>
              <a:t>. Association of methylation at cg26664492 and non-verbal cognitive skills in individual cohorts and in meta-analysis when genetic PCs were added to the model. </a:t>
            </a:r>
          </a:p>
          <a:p>
            <a:r>
              <a:rPr lang="en-GB" dirty="0" err="1"/>
              <a:t>genr</a:t>
            </a:r>
            <a:r>
              <a:rPr lang="en-GB" dirty="0"/>
              <a:t>=Generation R, meta=meta-analysis</a:t>
            </a:r>
          </a:p>
        </p:txBody>
      </p:sp>
    </p:spTree>
    <p:extLst>
      <p:ext uri="{BB962C8B-B14F-4D97-AF65-F5344CB8AC3E}">
        <p14:creationId xmlns:p14="http://schemas.microsoft.com/office/powerpoint/2010/main" val="24813269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c 2">
            <a:extLst>
              <a:ext uri="{FF2B5EF4-FFF2-40B4-BE49-F238E27FC236}">
                <a16:creationId xmlns:a16="http://schemas.microsoft.com/office/drawing/2014/main" id="{33AA2173-30AC-45BE-A4EE-CF92BE8BACB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49290" y="128895"/>
            <a:ext cx="8612777" cy="3612011"/>
          </a:xfrm>
          <a:prstGeom prst="rect">
            <a:avLst/>
          </a:prstGeom>
        </p:spPr>
      </p:pic>
      <p:pic>
        <p:nvPicPr>
          <p:cNvPr id="5" name="Picture 4" descr="A picture containing clock&#10;&#10;Description automatically generated">
            <a:extLst>
              <a:ext uri="{FF2B5EF4-FFF2-40B4-BE49-F238E27FC236}">
                <a16:creationId xmlns:a16="http://schemas.microsoft.com/office/drawing/2014/main" id="{46EDA77B-B4D4-45E5-802D-CA751757215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290" y="3427810"/>
            <a:ext cx="8612777" cy="277280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AA4E2D3-EC4B-457A-96FE-D895BCAF1747}"/>
              </a:ext>
            </a:extLst>
          </p:cNvPr>
          <p:cNvSpPr txBox="1"/>
          <p:nvPr/>
        </p:nvSpPr>
        <p:spPr>
          <a:xfrm>
            <a:off x="149290" y="128895"/>
            <a:ext cx="317241" cy="378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D10A50B-FA80-4DE8-9DBA-72A48C58FFD2}"/>
              </a:ext>
            </a:extLst>
          </p:cNvPr>
          <p:cNvSpPr txBox="1"/>
          <p:nvPr/>
        </p:nvSpPr>
        <p:spPr>
          <a:xfrm>
            <a:off x="149289" y="3238478"/>
            <a:ext cx="317241" cy="378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8917679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C144FAC0-D51E-4C66-818A-BE125D02C997}"/>
              </a:ext>
            </a:extLst>
          </p:cNvPr>
          <p:cNvSpPr/>
          <p:nvPr/>
        </p:nvSpPr>
        <p:spPr>
          <a:xfrm>
            <a:off x="80864" y="114516"/>
            <a:ext cx="1202093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Figure SF4</a:t>
            </a:r>
            <a:r>
              <a:rPr lang="en-GB" dirty="0"/>
              <a:t>. </a:t>
            </a:r>
            <a:r>
              <a:rPr lang="en-GB" i="1" dirty="0"/>
              <a:t>DUSP22</a:t>
            </a:r>
            <a:r>
              <a:rPr lang="en-GB" dirty="0"/>
              <a:t> mRNA expression A) across tissues (source: </a:t>
            </a:r>
            <a:r>
              <a:rPr lang="en-GB" dirty="0" err="1"/>
              <a:t>GTEx</a:t>
            </a:r>
            <a:r>
              <a:rPr lang="en-GB" dirty="0"/>
              <a:t>); B) across brain areas (source: </a:t>
            </a:r>
            <a:r>
              <a:rPr lang="en-GB" dirty="0" err="1"/>
              <a:t>Braineac</a:t>
            </a:r>
            <a:r>
              <a:rPr lang="en-GB" dirty="0"/>
              <a:t>). </a:t>
            </a:r>
          </a:p>
        </p:txBody>
      </p:sp>
    </p:spTree>
    <p:extLst>
      <p:ext uri="{BB962C8B-B14F-4D97-AF65-F5344CB8AC3E}">
        <p14:creationId xmlns:p14="http://schemas.microsoft.com/office/powerpoint/2010/main" val="63154162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0D3657D5-6984-42F3-B0D0-2E2A4CF3A66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4483966"/>
              </p:ext>
            </p:extLst>
          </p:nvPr>
        </p:nvGraphicFramePr>
        <p:xfrm>
          <a:off x="266700" y="173145"/>
          <a:ext cx="11658600" cy="4800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Acrobat Document" r:id="rId2" imgW="11658513" imgH="4800484" progId="AcroExch.Document.DC">
                  <p:embed/>
                </p:oleObj>
              </mc:Choice>
              <mc:Fallback>
                <p:oleObj name="Acrobat Document" r:id="rId2" imgW="11658513" imgH="4800484" progId="AcroExch.Document.DC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0D3657D5-6984-42F3-B0D0-2E2A4CF3A66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66700" y="173145"/>
                        <a:ext cx="11658600" cy="4800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5BC5C29F-E1DB-4247-8699-C7751CE5E66E}"/>
              </a:ext>
            </a:extLst>
          </p:cNvPr>
          <p:cNvSpPr txBox="1"/>
          <p:nvPr/>
        </p:nvSpPr>
        <p:spPr>
          <a:xfrm>
            <a:off x="266700" y="5154526"/>
            <a:ext cx="1158566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/>
              <a:t>Figure SF5</a:t>
            </a:r>
            <a:r>
              <a:rPr lang="en-GB" dirty="0"/>
              <a:t>. </a:t>
            </a:r>
            <a:r>
              <a:rPr lang="en-GB" i="1" dirty="0"/>
              <a:t>DUSP22</a:t>
            </a:r>
            <a:r>
              <a:rPr lang="en-GB" dirty="0"/>
              <a:t> DNA methylation across brain areas (BA10, BA20, BA7) and peripheral blood in N=16 participants, age 15-87 years (https://redgar598.shinyapps.io/BECon/).</a:t>
            </a:r>
          </a:p>
        </p:txBody>
      </p:sp>
    </p:spTree>
    <p:extLst>
      <p:ext uri="{BB962C8B-B14F-4D97-AF65-F5344CB8AC3E}">
        <p14:creationId xmlns:p14="http://schemas.microsoft.com/office/powerpoint/2010/main" val="15708981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45</TotalTime>
  <Words>377</Words>
  <Application>Microsoft Office PowerPoint</Application>
  <PresentationFormat>Widescreen</PresentationFormat>
  <Paragraphs>35</Paragraphs>
  <Slides>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Acrobat 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retta Caramaschi</dc:creator>
  <cp:lastModifiedBy>Doretta Caramaschi</cp:lastModifiedBy>
  <cp:revision>60</cp:revision>
  <dcterms:created xsi:type="dcterms:W3CDTF">2018-10-02T12:53:01Z</dcterms:created>
  <dcterms:modified xsi:type="dcterms:W3CDTF">2021-04-28T16:54:10Z</dcterms:modified>
</cp:coreProperties>
</file>